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21674138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6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1" d="100"/>
          <a:sy n="91" d="100"/>
        </p:scale>
        <p:origin x="1350" y="-5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547135"/>
            <a:ext cx="10363200" cy="754581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383941"/>
            <a:ext cx="9144000" cy="523289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05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5291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53947"/>
            <a:ext cx="2628900" cy="1836783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53947"/>
            <a:ext cx="7734300" cy="1836783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6658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8498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403489"/>
            <a:ext cx="10515600" cy="901583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504620"/>
            <a:ext cx="10515600" cy="474121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2429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769736"/>
            <a:ext cx="5181600" cy="137520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769736"/>
            <a:ext cx="5181600" cy="1375204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48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53952"/>
            <a:ext cx="10515600" cy="418933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313176"/>
            <a:ext cx="5157787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917081"/>
            <a:ext cx="5157787" cy="1164483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313176"/>
            <a:ext cx="5183188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917081"/>
            <a:ext cx="5183188" cy="1164483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202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673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192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120679"/>
            <a:ext cx="6172200" cy="1540268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481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120679"/>
            <a:ext cx="6172200" cy="1540268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9451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53952"/>
            <a:ext cx="10515600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769736"/>
            <a:ext cx="10515600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E4568-5ACD-435D-8C4D-5A025A52F662}" type="datetimeFigureOut">
              <a:rPr lang="en-GB" smtClean="0"/>
              <a:t>20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088720"/>
            <a:ext cx="41148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0DCC5-C67C-479D-96B6-5929D0B350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6000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69698" y="2708195"/>
            <a:ext cx="2739507" cy="2705413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8423" y="2735635"/>
            <a:ext cx="2683840" cy="2673521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267360" y="538566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856830" y="539137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094218" y="537348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51087" y="4118033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951087" y="3138214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951087" y="264721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951087" y="3619707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951087" y="5097853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951087" y="461636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932994" y="3907014"/>
            <a:ext cx="18453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vival probability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036287" y="4793068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7</a:t>
            </a:r>
            <a:endParaRPr lang="en-GB" sz="1400" b="1" dirty="0">
              <a:solidFill>
                <a:srgbClr val="96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990353" y="431601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9</a:t>
            </a:r>
            <a:endParaRPr lang="en-GB" sz="1400" b="1" dirty="0">
              <a:solidFill>
                <a:schemeClr val="tx1">
                  <a:lumMod val="50000"/>
                  <a:lumOff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515147" y="4991165"/>
            <a:ext cx="853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&lt; </a:t>
            </a:r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552434" y="5666319"/>
            <a:ext cx="2573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all survival time (years)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005280" y="537745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311214" y="538566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9410689" y="537224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994941" y="4118033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994941" y="3138214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994941" y="264721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994941" y="3619707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994941" y="5097853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994941" y="461636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5976848" y="3907014"/>
            <a:ext cx="18453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vival probability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9293163" y="418522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rgbClr val="96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6</a:t>
            </a:r>
            <a:endParaRPr lang="en-GB" sz="1400" b="1" dirty="0">
              <a:solidFill>
                <a:srgbClr val="96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9855112" y="386578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8</a:t>
            </a:r>
            <a:endParaRPr lang="en-GB" sz="1400" b="1" dirty="0">
              <a:solidFill>
                <a:schemeClr val="tx1">
                  <a:lumMod val="50000"/>
                  <a:lumOff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9484882" y="4994450"/>
            <a:ext cx="853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 &lt; </a:t>
            </a:r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7746812" y="5673479"/>
            <a:ext cx="2573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all survival time (years)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741079" y="2317968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0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6768475" y="2263943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0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3714438" y="2427858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AD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8578877" y="2440188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SC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8683519" y="536570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3446301" y="537348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729101" y="537348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GB" sz="1400" b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2851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3</TotalTime>
  <Words>51</Words>
  <Application>Microsoft Office PowerPoint</Application>
  <PresentationFormat>Custom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Pryfysgol Bangor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say McFarlane</dc:creator>
  <cp:lastModifiedBy>Ramsay McFarlane</cp:lastModifiedBy>
  <cp:revision>25</cp:revision>
  <cp:lastPrinted>2016-08-12T10:52:36Z</cp:lastPrinted>
  <dcterms:created xsi:type="dcterms:W3CDTF">2016-08-11T08:24:58Z</dcterms:created>
  <dcterms:modified xsi:type="dcterms:W3CDTF">2017-02-20T16:56:07Z</dcterms:modified>
</cp:coreProperties>
</file>